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3600" b="1" dirty="0">
                <a:solidFill>
                  <a:schemeClr val="bg1"/>
                </a:solidFill>
              </a:rPr>
              <a:t>Kidney and vascular involvement in Alagille syndrome</a:t>
            </a:r>
            <a:endParaRPr lang="fr-FR" sz="3600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304861"/>
            <a:ext cx="1194163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pPr marL="249238" indent="-249238"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Kidney involvement in 38% of patients, and can reveal the disease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pPr defTabSz="830263"/>
            <a:r>
              <a:rPr lang="en-GB" dirty="0">
                <a:solidFill>
                  <a:srgbClr val="003969"/>
                </a:solidFill>
              </a:rPr>
              <a:t>2. Type of kidney involvement 	Congenital abnormalities of the kidney and urinary tract in 22% of patients </a:t>
            </a:r>
          </a:p>
          <a:p>
            <a:pPr defTabSz="830263"/>
            <a:r>
              <a:rPr lang="en-GB" dirty="0">
                <a:solidFill>
                  <a:srgbClr val="003969"/>
                </a:solidFill>
              </a:rPr>
              <a:t>				Hyperchloremic acidosis in 9%</a:t>
            </a:r>
          </a:p>
          <a:p>
            <a:pPr defTabSz="830263"/>
            <a:r>
              <a:rPr lang="en-GB" dirty="0">
                <a:solidFill>
                  <a:srgbClr val="003969"/>
                </a:solidFill>
              </a:rPr>
              <a:t>				Glomerulopathy and/or proteinuria in 6%,</a:t>
            </a:r>
          </a:p>
          <a:p>
            <a:pPr defTabSz="828675"/>
            <a:r>
              <a:rPr lang="en-GB" dirty="0">
                <a:solidFill>
                  <a:srgbClr val="003969"/>
                </a:solidFill>
              </a:rPr>
              <a:t>				↘ Glomerular filtration rate in 10% and 	       after liver transplantation</a:t>
            </a:r>
          </a:p>
          <a:p>
            <a:pPr defTabSz="830263"/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Vascular involvement 	Stenosis/hypoplasia of the branch pulmonary arteries in 76% of patients</a:t>
            </a:r>
          </a:p>
          <a:p>
            <a:r>
              <a:rPr lang="en-GB" dirty="0">
                <a:solidFill>
                  <a:srgbClr val="003969"/>
                </a:solidFill>
              </a:rPr>
              <a:t>			Noncardiac vascular anomalies or events in 9% </a:t>
            </a:r>
          </a:p>
          <a:p>
            <a:r>
              <a:rPr lang="en-GB" dirty="0">
                <a:solidFill>
                  <a:srgbClr val="003969"/>
                </a:solidFill>
              </a:rPr>
              <a:t>			Renal artery stenosis and mid aortic syndrome frequently reported</a:t>
            </a:r>
          </a:p>
          <a:p>
            <a:r>
              <a:rPr lang="en-GB" dirty="0">
                <a:solidFill>
                  <a:srgbClr val="003969"/>
                </a:solidFill>
              </a:rPr>
              <a:t>			Vasculopathy can progress over the life of the patient</a:t>
            </a:r>
          </a:p>
          <a:p>
            <a:r>
              <a:rPr lang="en-GB" dirty="0">
                <a:solidFill>
                  <a:srgbClr val="003969"/>
                </a:solidFill>
              </a:rPr>
              <a:t>			Vascular complications account for 15% of deaths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anchi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</a:p>
          <a:p>
            <a:r>
              <a:rPr lang="en-GB" b="1" dirty="0">
                <a:solidFill>
                  <a:schemeClr val="bg1"/>
                </a:solidFill>
              </a:rPr>
              <a:t>Kidney and vascular involvement in Alagille syndrome are frequent,</a:t>
            </a:r>
          </a:p>
          <a:p>
            <a:r>
              <a:rPr lang="en-GB" b="1" dirty="0">
                <a:solidFill>
                  <a:schemeClr val="bg1"/>
                </a:solidFill>
              </a:rPr>
              <a:t>often asymptomatic or pauci-symptomatic, and have to be diagnosed.</a:t>
            </a:r>
            <a:endParaRPr lang="fr-FR" b="1" dirty="0">
              <a:solidFill>
                <a:schemeClr val="bg1"/>
              </a:solidFill>
            </a:endParaRPr>
          </a:p>
        </p:txBody>
      </p:sp>
      <p:pic>
        <p:nvPicPr>
          <p:cNvPr id="1026" name="Picture 2" descr="Vecteur Stock Warning, Warning sign Icon, Warning sign, illustration.sign,  Red warning | Adobe Stock">
            <a:extLst>
              <a:ext uri="{FF2B5EF4-FFF2-40B4-BE49-F238E27FC236}">
                <a16:creationId xmlns:a16="http://schemas.microsoft.com/office/drawing/2014/main" id="{FD44888F-2475-4E3B-9B7E-EB271839E39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93" b="14609"/>
          <a:stretch/>
        </p:blipFill>
        <p:spPr bwMode="auto">
          <a:xfrm>
            <a:off x="7506788" y="2998525"/>
            <a:ext cx="659223" cy="5684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2</TotalTime>
  <Words>175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9</cp:revision>
  <dcterms:created xsi:type="dcterms:W3CDTF">2019-06-13T12:30:18Z</dcterms:created>
  <dcterms:modified xsi:type="dcterms:W3CDTF">2024-10-11T19:33:32Z</dcterms:modified>
</cp:coreProperties>
</file>